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4817E9-7C2B-43CB-9074-03CA13BE00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E3665D-968C-4B38-B357-965605F8CB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9F026-CF30-4F1F-BE7E-28B496275F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2606B7-C935-45B0-9480-A844C9B109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150CD-BE56-4664-90E9-B74ED7F6E9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76AB07-0FD1-487C-BF52-06791D0A52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3C97D8-FE4F-4609-85FA-DA0186AD58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78CA9-C4CC-4B62-A5ED-0398DE98D7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932BE0-DCC5-4F9D-8240-703B29A308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F61A9-C585-4715-AF6B-EC017D092A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AB72D4-DC07-4CFB-9BD9-A1A4800227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BACDE-97F1-486D-AB1D-F5392B7BD0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7E3AB1B-593A-4453-85C7-D5452A41310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191120" y="3048120"/>
            <a:ext cx="0" cy="2895480"/>
          </a:xfrm>
          <a:prstGeom prst="line">
            <a:avLst/>
          </a:prstGeom>
          <a:ln w="25560">
            <a:solidFill>
              <a:srgbClr val="ff00ff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0" t="0" r="2078" b="0"/>
          <a:stretch/>
        </p:blipFill>
        <p:spPr>
          <a:xfrm>
            <a:off x="5029200" y="1676520"/>
            <a:ext cx="2685960" cy="464796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rcRect l="0" t="0" r="2078" b="4894"/>
          <a:stretch/>
        </p:blipFill>
        <p:spPr>
          <a:xfrm>
            <a:off x="685800" y="1676520"/>
            <a:ext cx="2755800" cy="441936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309960" y="1219320"/>
            <a:ext cx="376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ntra-species homologs  N-termin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881960" y="1219320"/>
            <a:ext cx="376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ntra-species homologs  C-termin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80880" y="6324480"/>
            <a:ext cx="409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ff"/>
                </a:solidFill>
                <a:latin typeface="Arial"/>
              </a:rPr>
              <a:t>DNA-bind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724280" y="6324480"/>
            <a:ext cx="409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ff"/>
                </a:solidFill>
                <a:latin typeface="Arial"/>
              </a:rPr>
              <a:t>substrate-bind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661200" y="3681360"/>
            <a:ext cx="122796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0066"/>
                </a:solidFill>
                <a:latin typeface="Arial"/>
              </a:rPr>
              <a:t>‘</a:t>
            </a:r>
            <a:r>
              <a:rPr b="1" lang="en-US" sz="1600" spc="-1" strike="noStrike">
                <a:solidFill>
                  <a:srgbClr val="ff0066"/>
                </a:solidFill>
                <a:latin typeface="Arial"/>
              </a:rPr>
              <a:t>CcpA-like’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191120" y="1981080"/>
            <a:ext cx="0" cy="914400"/>
          </a:xfrm>
          <a:prstGeom prst="line">
            <a:avLst/>
          </a:prstGeom>
          <a:ln w="25560">
            <a:solidFill>
              <a:srgbClr val="8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661200" y="2209680"/>
            <a:ext cx="122796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800000"/>
                </a:solidFill>
                <a:latin typeface="Arial"/>
              </a:rPr>
              <a:t>‘</a:t>
            </a:r>
            <a:r>
              <a:rPr b="1" lang="en-US" sz="1600" spc="-1" strike="noStrike">
                <a:solidFill>
                  <a:srgbClr val="800000"/>
                </a:solidFill>
                <a:latin typeface="Arial"/>
              </a:rPr>
              <a:t>EbgR-like’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"/>
          <p:cNvSpPr/>
          <p:nvPr/>
        </p:nvSpPr>
        <p:spPr>
          <a:xfrm>
            <a:off x="3429000" y="457200"/>
            <a:ext cx="5029200" cy="30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34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----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</a:rPr>
              <a:t>M</a:t>
            </a: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PTIREIAAKAGYSPATVSRLLNNDPSFSISDHARKKILQTAQNLNYEQPNTTH-GLAYQIATIFAVQPKQE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34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---MAATLKDIANKVGVSLATVSRVLNKDQSLSVSDTTRQRILDAAEALQYSKNKRHT-VTTARKRLAIVQWYSE--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347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-MTMAVTLKDIAQRADVSLATVSRVLNYDKTLSVSEQTRKRVFTIAGELRYSKRKRQHIKALMRKNIAVIQWYSKIQ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36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---MSVTIKDIARKVGVAPSTVSRVLSNKSK-YYTSETAEMVRKAARELGYKKNQAAV-ELVKKSSNVIAAVVSSVR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35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---MKPTIKDIAAKTGFSIATVSRVLAKKQG-TYSDKTQERILKVAKDLGYRKNTLAM-ELVKKKTDVIAVIVNVTP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01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---MKPKLNDVAKLAGVSATTVSRVINNHG--YLSSQTKEKVFAAMRELHYQPNNMAR-SLQGKNTRLIGVIFSDIS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017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----MITLNDVAKKANVSKMTVSRVINHPE--QVRPELREMILNVMTQLDYHPNAAAR-ALVGRRTRVVKLTIFEDM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32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----MTTISEIAAEAGVGVGTVSRYLNHRP--SVSVAKKKQIQAAIEKLDYTPNAIAS-QLRAQSTNTIGVLVSRIS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26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----MTNIHDIARLSGYSVSTVSRVINHQK--YVADDKRKKIEALIKELDYVPNRLAR-DLSKGQTKTIGIVLPYAN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225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MEKQTVTIYDVAREAAVSMATVSRVVNGNP--NVKPATRKKVLAVIERLDYRPNAVAR-GLASKRSTTVGVIIPDVT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017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----MATIKDVAQRAGVSPSTASRAMHGSK--IISKPTRDKVIKAARELNYAPDFNAQ-NLATKASNTIGVVLPVDH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&gt;LPL036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800" spc="-1" strike="noStrike">
                <a:solidFill>
                  <a:srgbClr val="000000"/>
                </a:solidFill>
                <a:latin typeface="Courier New"/>
              </a:rPr>
              <a:t>MKNKAVTIKDVARLAERSIATVSQILNGHGD-KFSAATVAKVEAARDELNYEPDYFAQ-RMIKKTSKTIGVLVPDIR-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28600" y="457200"/>
            <a:ext cx="31399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ultiple sequence alignment of the N-terminal 80 a.a. of the LacI-TF homologs of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L. plantarum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/>
          <p:nvPr/>
        </p:nvSpPr>
        <p:spPr>
          <a:xfrm>
            <a:off x="228600" y="457200"/>
            <a:ext cx="313992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ootstrapped NJ-tree of the N-terminal 80 a.a. of the LacI-TF homologs of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L. plantarum.  .phb form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905120" y="2514600"/>
            <a:ext cx="5943600" cy="256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((LPL03470:0.7812,(LPL03479:0.3890,LPL03488:0.2239):0.4196[991]):0.0552[368],((LPL03531:0.3789,LPL03625:0.4196):0.2271[765],(((LPL02256:0.3268,LPL00173:0.6858):0.1543[385],(LPL02602:0.5052,LPL03221:0.5074):0.0958[408]):0.0639[117],(LPL00188:0.4561,(LPL03661:0.5422,LPL00172:0.4234):0.2176[745]):0.0666[171]):0.1371[326]):0.0552)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"/>
          <p:cNvSpPr/>
          <p:nvPr/>
        </p:nvSpPr>
        <p:spPr>
          <a:xfrm>
            <a:off x="152280" y="1371600"/>
            <a:ext cx="8991720" cy="457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260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---------VDGIVSAGFAKGYKVTLLPTNY-DMTVERHYLEQLKSKAYDALIFTSRSNSLEALER-YQKYGRIVCCED-PGTSS-HLAAAYTDRLASYISALMWAKQQGCQNVGVVISRDNLISA----SSRVTRMAYQETYGKLPAAN----LFTGAVTFEDGYRAGRYFAKLKP---SVDAILANGDDIGAGIQDYYRVHQLT---PVKIIGQENLLSSRLM--QFSTIDHHLEALGKAAFELSISHGQ----KHQ-------LIKSEFIER---------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017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------MMLLAGIANELNQHQYALQIATRNSYEV------------GECDGYILTGIRQADYAW---VERLNQPVVFVG---SNRQGYDYVDTNNYQAVWESTRYAAEQGYTHLVFIGIAIAEP------FELDRERGFREYVTTHHISA--QIIRLANHSHVATAYVKSHWSGFP----RNTAFICASDRLAIGVETAIINQGGRVPIEYGIIGFDGVLLNQIAAKRLTTMKQPLEAMGRAAARLLLANINHTDRSRGRHDQEKIIINSRLSVAESTR-----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34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------SNLRQSLVEHGKQANLKLT--FYPDIDH----------IPHDIDGVMAVG-EFDSDALHK-LRQLTPHRIFVD-SNPDPHHFNSVQPNLQAITEQAIDQLIAAGDTPIGLINGGYWNKDQQVTHQQDPRQKYFESRLRELQLFDSRFLFIGGEFSVASGYRLGQQVVQSLSKQALPKGFLVGSDPLAVGVLQAFNENKITVPTDTAIISINDIDIARYVSPPLTTFHIDTDDLAAQAITTLKDTII----FDR-SQKRMVLVDTKLIYRKSFVKPTNK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348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---LYYMSVRMGIERRGQDNQFEVTRIFQNNLQE----------LGPDVDAVIAVG-KFSEPQVKD-LASVTDNLVFVD-DDQFDAGFDSVITDFRLATEKVVDYFWQRNFHHIGFIHGQEMTTDHQLA-VVDRRMLGFRAAMERRHAFD-PKFVFKGDYTSESGFKMMQKAIRKLGDQ-LPGAFFVANDPMAAGALKALQASGIQVPERVKLFSFNNTSLATFVYPELSAVNVDTELMGATAVNLVISRLA----GRT--TTQRVELGTNLVERASSK-----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347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HDDLYYLAIRKGIEHQAQVCGFTTTSIFQNNLDQ----------VGDDIDAIVAVG-KFSPVQVQQ-LSRLSSQLVFVD-DDHFAQGFSSVVTDFTFATNRVVDYFWRRGIRDIGMIYGKEWSTDQQVE-IPNQRQQSFEQALQRHHAYH-AEYVLAGDYTSQSGYLMMKRAIEMLGDR-LPHAFFIANDPMAAGALKALQQADIAVPQRVKLFSFNNTTLAEYVYPEISSVNVETELMGKTAIDLLVSRFQ----DDR-QAAQRIELGTTLVERESTK-----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017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----FFLEMIRGINEVCSKNGAMTTLATGISSDE-LVHNIDVMIAQGHIKTFILLYSEKNDPVVER-LKQFDVQYVVIGKPYQDVNKTSYVDNDNIQAGTDAAQYLIDHGHRRIGFLYSDLSRM------VQSDRMLGYQRVMMQNQLPN--IMLEERFETHAAGVKTLHKFFEQYP---DVTGFVAVDDMLALKLQQVLHNDPNWKVKQFSLIGFNNSIFSDLAHPMLTSIAVFPQRLGEEAAKIAMADHP----ADE--LSTAVIVPHQIVKRHSVHQIKSLQ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322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---------FDALERELNGYGFQVMVMQTHD-DALAEQHFLDKLKQQQVDGVILASIENQQLVAQL-SATYANQMVLLN-EEATDIGIPMISLNHYQATKDALAYLYHQGHRRIAYATGGDFPSTH----HGRSRTQAYLDFCEEQQLVVNNNWVFAQQHTIADGQALGKQLASLNPSD-RPTAVFTNSDEVAVGVIDELQQQHFRVPDDMAVMGYDDQPFAAVAQVPLTTVRQPVAAMAQLAVDQLLHHLG----RLQ-RPELAIDLSLDLIKRKSA------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366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----FFGELLRGIENVLYQQNFITMLC-NADLDEDKERVYLDELSRRGVDGFIIASSAVSNNAINDILRQKGHPFIVLD-QKRAEGFSDSVLTDDYDGGRQAAQHLKDLGHRQVAVLIPAKPSA------NVQKRLSGFYSVYPRTAVH-----VIATPLSKVGGRQVVPEILAT-----GVTGIFAVNDEIAFGVYLGMAEHDKRIPDDYSVIGYDDVEMCQYVAPQLTTIAQPIFELGQTTANQLLDRIA----NPQ-QPWEEHHLPVKLIERNSTAHLN--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018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--------LVSRIEKILFAKNYKVILCNSAD-DPQKERDYLQMLMANQVDGIIAGA---HNLGIEE-YQQYGLPIISFD--RYLSDNIPIVSSDNYQGGWLATQTLHQAGATNVAIFTGKSHAGS-----PTNGRREGYEAYLTAQQLTP---HVHELPFELTPALKMME--IKTIMTQHQYDGIFCSDDLTALLVLNVARQLSLTVPEQLRVVGYDGTALIRDYHSELTTVEQPLADISTLLVSLLLQRIE----DANCTLESKYTLPVKLIKGLTA------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225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-----FAALARGIDDIAMMYKYNIILTNSDDAGE-QEVNVLNTLMAKQVDGVIFMGNHIDDKLRAE-FKRAKAPVVLAG-TVDPNNETPSVNIDYAAAVEEVVTNLIARGHKKIALALGSLSQSI-----NAEYRLTGYKRALTKAKIPFDDALVYEAGYSYDAGRKLQPVIADS-----GATAVFVGDDEMAAGLINASMESGINVPDDLEVVTSNDTIITQITRPAITSITQPLYDIGAVAMRMLTKLMN----DKE-LDEKTVTLPYGIVRRGSTKSAD--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362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-------QILDGIQEEAHKNGYNLIIVYSGSADPEEQKHALLTAIERPVMGILLLSIALTDDNLQL-LQSSDVPYCFLS--MGFDDDRPFISSDDEDIGYQATNLLINEGHRQIGIAGIDQYPY------TGRKRLAGYKKALKEANIAINQEWIKPGDYSYTSGEQAMKAFGKNT----DLTGIIAASDMTAIGILNQASSFGIEVPKDLSIVSIDGTEMCKITRPQLTSISQDFFQMGVTGVQQIHQSVK----NGSNRIVSQQFIPVNPVIRKSTARLG--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&gt;LPL0353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600" spc="-1" strike="noStrike">
                <a:solidFill>
                  <a:srgbClr val="000000"/>
                </a:solidFill>
                <a:latin typeface="Courier New"/>
              </a:rPr>
              <a:t>-------GIIDGIQQRATEIGLQVIILYAGNRNTELQHQAIVTALERTVSGILLMAIEPDKADLQL-LTESKTPFCFVS-INLADERVKSVSSDNYQAAYLATKYLISHGHRTIGLAGIDHYH-------TGSQRLAGYQAALKDYSIHGQAEWVQPGDYSYQAGYNVFNAYQEL-----GITGVVAASDMTAAGLQKAAQESNVKLPGALSVVSIDGTLICDIATPALTSVTQNFVQIGIESVNCLVGKSA----TRL--------VPVTLVERESVATI----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28600" y="380880"/>
            <a:ext cx="313992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ultiple sequence alignment of the C-terminal (-80 N-terminal a.a.) of the LacI-TF homologs of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L. plantarum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"/>
          <p:cNvSpPr/>
          <p:nvPr/>
        </p:nvSpPr>
        <p:spPr>
          <a:xfrm>
            <a:off x="228600" y="380880"/>
            <a:ext cx="31399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J-tree of the C-terminal (-80 N-terminal a.a.) of the LacI-TF homologs of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L. plantarum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905120" y="2286000"/>
            <a:ext cx="5257800" cy="256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800" spc="-1" strike="noStrike">
                <a:solidFill>
                  <a:srgbClr val="000000"/>
                </a:solidFill>
                <a:latin typeface="Arial"/>
              </a:rPr>
              <a:t>((LPL03470:0.9411,(LPL03488:0.3070,LPL03479:0.3117):0.5415[998]):0.2708[951],(((((LPL02602:1.6428,LPL00188:0.7972):0.1803[474],LPL03221:0.9097):0.1500[328],LPL03661:0.7460):0.1718[421],LPL00173:1.2728):0.0588[209],(LPL02256:0.9530,(LPL00172:1.3258,(LPL03625:0.4781,LPL03531:0.4795):0.4554[994]):0.0605[301]):0.0907[313]):0.2708)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19T06:44:43Z</dcterms:created>
  <dc:creator>cfrancke</dc:creator>
  <dc:description/>
  <dc:language>en-US</dc:language>
  <cp:lastModifiedBy>cfrancke</cp:lastModifiedBy>
  <dcterms:modified xsi:type="dcterms:W3CDTF">2008-03-17T12:55:57Z</dcterms:modified>
  <cp:revision>5</cp:revision>
  <dc:subject/>
  <dc:title>Slide 1</dc:title>
</cp:coreProperties>
</file>